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536" y="-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116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526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280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468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799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750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057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0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306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97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017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94E28-D027-4690-A49C-FF47BBC93C4B}" type="datetimeFigureOut">
              <a:rPr lang="en-US" smtClean="0"/>
              <a:t>9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2ED91-6C34-4E13-B8DE-CCA254551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56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37710" y="621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77332" y="621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10400" y="621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96132" y="621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257" y="615950"/>
            <a:ext cx="2474913" cy="2813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788" y="609600"/>
            <a:ext cx="2501900" cy="2813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4688" y="609600"/>
            <a:ext cx="2382837" cy="249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6663" y="612648"/>
            <a:ext cx="2446337" cy="2813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0" y="3581400"/>
            <a:ext cx="90678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smtClean="0"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ltere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nate mediators and SLE-associated autoantibodies in SLE patients and lupus relative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asma levels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NF-α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, IFN-b (B), anti-dsDNA (C), as well as number of SLE-associated autoantibody specificities (including autoantibodies to dsDNA, chromatin, Ro/SSA, La/SSB, Sm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mRN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and RNP) wer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sessed in SLE patients (case), unaffected first-degree relatives of SLE patients (FDR), and unrelated, unaffected controls with no family history of SLE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re presented as mean </a:t>
            </a:r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M. 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Wallis test with Dunn’s multiple comparison.</a:t>
            </a:r>
          </a:p>
        </p:txBody>
      </p:sp>
    </p:spTree>
    <p:extLst>
      <p:ext uri="{BB962C8B-B14F-4D97-AF65-F5344CB8AC3E}">
        <p14:creationId xmlns:p14="http://schemas.microsoft.com/office/powerpoint/2010/main" val="1194712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</TotalTime>
  <Words>12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Munroe, MD, PhD</dc:creator>
  <cp:lastModifiedBy>Melissa Munroe, MD, PhD</cp:lastModifiedBy>
  <cp:revision>14</cp:revision>
  <cp:lastPrinted>2016-09-27T18:20:05Z</cp:lastPrinted>
  <dcterms:created xsi:type="dcterms:W3CDTF">2014-12-15T16:54:42Z</dcterms:created>
  <dcterms:modified xsi:type="dcterms:W3CDTF">2016-09-27T19:41:32Z</dcterms:modified>
</cp:coreProperties>
</file>